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ryn" initials="K" lastIdx="1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7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60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316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768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791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61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90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0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017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919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82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440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38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83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731031" y="1206500"/>
            <a:ext cx="7933212" cy="372491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57400" y="5105400"/>
            <a:ext cx="5638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1 </a:t>
            </a:r>
            <a:r>
              <a:rPr lang="en-US" dirty="0" smtClean="0"/>
              <a:t>Marker density among wheat chromosomes. Number of unique markers is defined as the number of markers that are at different positions of the consensus map (Wang et al 2014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0768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445</TotalTime>
  <Words>3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nome Wide Association Study (GWAS) of Leaf rust resistance in world wide wheat breeding lines</dc:title>
  <dc:creator>lgao</dc:creator>
  <cp:lastModifiedBy>lgao</cp:lastModifiedBy>
  <cp:revision>238</cp:revision>
  <dcterms:created xsi:type="dcterms:W3CDTF">2015-03-13T17:33:15Z</dcterms:created>
  <dcterms:modified xsi:type="dcterms:W3CDTF">2016-01-14T21:25:24Z</dcterms:modified>
</cp:coreProperties>
</file>